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38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6115F0-89A0-414B-88F0-972290EADF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7FE2EE-640D-420F-B93C-897FCD75AD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B072A7-6C05-4EEF-BA2C-D93F7D91E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8B7A-F538-4A30-B410-885DF12B97FB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C50FB7-4CB5-413B-A356-9FEEF96BB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BBAF56-BEB7-4796-BF26-4AAD89BD1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7A02-B712-43EC-A0AF-C2739214817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8610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DF002A-5726-41E2-B1ED-F42A83507B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7BF4FE-5C3A-4428-BE90-CF5E671735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AD4039-8589-45E8-BF62-E8C3A7F28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8B7A-F538-4A30-B410-885DF12B97FB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F0EF05-257B-4178-8AAD-44F7FE6D72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643B28-F4C8-4641-A7A0-8598B34F2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7A02-B712-43EC-A0AF-C2739214817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55532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8DDCC2-B8FC-45DE-A4BD-C2E80D9C8B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BDC23C6-D266-4270-BE0A-E537329C3B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414C30-5E42-4B44-B306-413CE10B62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8B7A-F538-4A30-B410-885DF12B97FB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1EA5E9-EF6B-45BB-A290-7760255DA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E9811D-1847-435C-892C-A1F5479B5D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7A02-B712-43EC-A0AF-C2739214817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49492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0C5413-C84B-4346-A966-BBBA777870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A18E8C-E7C2-48E4-AE64-B26B118202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4B5B8B-DA32-4A6E-8A75-B304F71DE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8B7A-F538-4A30-B410-885DF12B97FB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3A40D1-F3CE-465D-A151-402AFE356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3E3A21-7533-46C8-AADE-C45231356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7A02-B712-43EC-A0AF-C2739214817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33243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E8ABF4-4935-48E1-A2EC-51969A3D50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78A712-9F40-42DD-A686-0008690DE3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2E5B2C-E7FD-4418-A846-4DCDA5CC08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8B7A-F538-4A30-B410-885DF12B97FB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1D26A5-A818-4639-A7F7-6302499D6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E308C3-E223-4E77-AFF9-CB4D5DAC3F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7A02-B712-43EC-A0AF-C2739214817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1114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E55472-B777-411B-A686-9E1FDC988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7109DD-A694-45D7-AFA4-59939795AAA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CE0772-5719-45DB-AFE6-94C1F021B2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118F56-D97F-4063-BDAE-FDA795823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8B7A-F538-4A30-B410-885DF12B97FB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1F7262-305F-4D73-93BC-8A158AE30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1A2306-D4BB-4F5E-BE74-0A233449E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7A02-B712-43EC-A0AF-C2739214817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9508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6C7B16-1BBF-4009-BB42-9080852D51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8F5970-838A-450B-9759-CA976C899A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7E867C-4AFD-490C-8457-0EA3F7B5DA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EBE1009-C133-48A6-9C42-271183051D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D3CF9E-783E-4B4D-954C-AF97F2668A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3C4C3B1-1D97-4FA4-91C4-AE4295E80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8B7A-F538-4A30-B410-885DF12B97FB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4B9C41-6E7E-49BE-BF90-2083C90C3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57961A5-55D4-410B-8C2C-34FEE5B8FA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7A02-B712-43EC-A0AF-C2739214817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23363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BD076D-C403-4686-86D6-E06202C69A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6E8DBA-0ABA-4C36-84CD-D6A91A8D0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8B7A-F538-4A30-B410-885DF12B97FB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CB88E22-448D-47F3-9AA9-13758093F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E6E14FE-37AC-4658-A0CC-E3AE390679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7A02-B712-43EC-A0AF-C2739214817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0708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FE9CA5-1E0A-4D62-9C61-22C75C46A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8B7A-F538-4A30-B410-885DF12B97FB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7CE2D59-995B-4100-8C78-7C705C1128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620D23E-C643-4AB4-997F-D5D3FF0DA7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7A02-B712-43EC-A0AF-C2739214817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3105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F8781E-64DB-4B61-827A-D6564404BC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FB48D5-DB4F-4AC1-8896-CA70CB70E9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C85F3F-A587-468F-A4CB-A630CCB085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6587B0-B4E1-42A9-A9AB-E76686ACC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8B7A-F538-4A30-B410-885DF12B97FB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A05124-1B28-404D-85C6-4B0EE000AF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91045E-EF35-43F5-9E83-1CA0E9990A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7A02-B712-43EC-A0AF-C2739214817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14221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31C977-91C6-43D6-9F61-01CFCAE2D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E18F3E5-30A1-4EDB-BC6D-D93FC88154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E3F5C9-07E6-4B38-A124-5421B353C4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6A8A0C-ADE2-4F18-8B02-AD9A9C8DDF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48B7A-F538-4A30-B410-885DF12B97FB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034D5D-CEE9-4E7F-83D4-EE9D43BB2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AFEE33-45C9-4FC6-8DAF-687D52CE7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87A02-B712-43EC-A0AF-C2739214817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2212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08EDAAB-B38B-4900-8A9B-1B51C0340A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567C76-8685-4458-9344-C988B16C1C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7C8E9D-688D-437C-8FB2-F886E8EBE2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948B7A-F538-4A30-B410-885DF12B97FB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038C7B-87AB-433B-9FD9-62FC628DC1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3D09AD-D4C1-4C16-8218-B5A9086359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587A02-B712-43EC-A0AF-C2739214817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7089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13" Type="http://schemas.openxmlformats.org/officeDocument/2006/relationships/image" Target="../media/image14.jpeg"/><Relationship Id="rId3" Type="http://schemas.openxmlformats.org/officeDocument/2006/relationships/image" Target="../media/image4.jpeg"/><Relationship Id="rId7" Type="http://schemas.openxmlformats.org/officeDocument/2006/relationships/image" Target="../media/image8.jpeg"/><Relationship Id="rId12" Type="http://schemas.openxmlformats.org/officeDocument/2006/relationships/image" Target="../media/image13.jpeg"/><Relationship Id="rId17" Type="http://schemas.openxmlformats.org/officeDocument/2006/relationships/image" Target="../media/image18.jpeg"/><Relationship Id="rId2" Type="http://schemas.openxmlformats.org/officeDocument/2006/relationships/image" Target="../media/image3.jpeg"/><Relationship Id="rId16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jpeg"/><Relationship Id="rId11" Type="http://schemas.openxmlformats.org/officeDocument/2006/relationships/image" Target="../media/image12.jpeg"/><Relationship Id="rId5" Type="http://schemas.openxmlformats.org/officeDocument/2006/relationships/image" Target="../media/image6.jpeg"/><Relationship Id="rId15" Type="http://schemas.openxmlformats.org/officeDocument/2006/relationships/image" Target="../media/image16.jpeg"/><Relationship Id="rId10" Type="http://schemas.openxmlformats.org/officeDocument/2006/relationships/image" Target="../media/image11.jpeg"/><Relationship Id="rId4" Type="http://schemas.openxmlformats.org/officeDocument/2006/relationships/image" Target="../media/image5.jpeg"/><Relationship Id="rId9" Type="http://schemas.openxmlformats.org/officeDocument/2006/relationships/image" Target="../media/image10.jpeg"/><Relationship Id="rId14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02CF6E0B-E910-452C-B006-35B12671610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58621" y="1256037"/>
          <a:ext cx="4709878" cy="41219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2" name="Prism 8" r:id="rId3" imgW="5506941" imgH="4819886" progId="Prism8.Document">
                  <p:embed/>
                </p:oleObj>
              </mc:Choice>
              <mc:Fallback>
                <p:oleObj name="Prism 8" r:id="rId3" imgW="5506941" imgH="4819886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02CF6E0B-E910-452C-B006-35B1267161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8621" y="1256037"/>
                        <a:ext cx="4709878" cy="41219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00787BD-0C72-4F97-8EC5-CF03AC40732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55617" y="1256037"/>
          <a:ext cx="4709878" cy="41219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3" name="Prism 8" r:id="rId5" imgW="5506941" imgH="4819886" progId="Prism8.Document">
                  <p:embed/>
                </p:oleObj>
              </mc:Choice>
              <mc:Fallback>
                <p:oleObj name="Prism 8" r:id="rId5" imgW="5506941" imgH="4819886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00787BD-0C72-4F97-8EC5-CF03AC4073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55617" y="1256037"/>
                        <a:ext cx="4709878" cy="41219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21DA407E-37EC-40E9-82CF-F49C2DA1A005}"/>
              </a:ext>
            </a:extLst>
          </p:cNvPr>
          <p:cNvSpPr txBox="1"/>
          <p:nvPr/>
        </p:nvSpPr>
        <p:spPr>
          <a:xfrm>
            <a:off x="158621" y="248033"/>
            <a:ext cx="1599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Supplement Figur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4DC8300-D939-46A1-9090-34B5CB9D0440}"/>
              </a:ext>
            </a:extLst>
          </p:cNvPr>
          <p:cNvSpPr txBox="1"/>
          <p:nvPr/>
        </p:nvSpPr>
        <p:spPr>
          <a:xfrm>
            <a:off x="665825" y="5765857"/>
            <a:ext cx="795439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Supplement </a:t>
            </a:r>
            <a:r>
              <a:rPr lang="en-US" sz="1600" i="1" dirty="0"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Figure</a:t>
            </a:r>
            <a:r>
              <a:rPr lang="en-US" sz="16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 1: A patient sample was used for two 10-fold dilution series in 1:1 </a:t>
            </a:r>
            <a:r>
              <a:rPr lang="en-US" sz="16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cobas</a:t>
            </a:r>
            <a:r>
              <a:rPr lang="en-US" sz="16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 PCR Media and </a:t>
            </a:r>
            <a:r>
              <a:rPr lang="en-US" sz="16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eSwab</a:t>
            </a:r>
            <a:r>
              <a:rPr lang="en-US" sz="16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 medium, one </a:t>
            </a:r>
            <a:r>
              <a:rPr lang="en-US" sz="1600" i="1" dirty="0"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containing </a:t>
            </a:r>
            <a:r>
              <a:rPr lang="en-US" sz="1600" i="1" dirty="0" err="1"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Vaxigrip</a:t>
            </a:r>
            <a:r>
              <a:rPr lang="en-US" sz="1600" i="1" dirty="0"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 tetravalent Influenza vaccine in order to rule out relevant interference of high levels of Influenza-RNA for SARS-CoV-2 detection.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31517726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64F862A-7C02-43C3-98F5-3C3F15963AF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4102" y="5123887"/>
            <a:ext cx="1440000" cy="1440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9975AC2A-75BE-47A8-BE98-1FA2CA4991C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6834" y="3683887"/>
            <a:ext cx="1440000" cy="14400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D6CC9D3F-8BB1-4500-9C10-64C3B75EAA7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6834" y="2266747"/>
            <a:ext cx="1440000" cy="14400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C5BE8194-F9D5-405C-930F-F7263AD0521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566" y="2243887"/>
            <a:ext cx="1440000" cy="14400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6A73662E-06DF-4A17-B81F-796BC051A96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566" y="821328"/>
            <a:ext cx="1440000" cy="144000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56C2A7A7-548C-4BEC-A172-97B568BD392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2298" y="2243887"/>
            <a:ext cx="1440000" cy="144000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702F6E3E-A159-47DB-B286-797AE1233552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2298" y="816474"/>
            <a:ext cx="1440000" cy="144000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8158996A-A3BB-4266-859D-E7D9C4F8A051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4102" y="3683887"/>
            <a:ext cx="1440000" cy="144000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1BA7E214-EBE3-471F-A586-EA124898641F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4102" y="2266747"/>
            <a:ext cx="1440000" cy="144000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1F6A464F-D117-40C0-ACA5-398CFA9343A7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4102" y="826747"/>
            <a:ext cx="1440000" cy="14400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7EAFF476-44A6-4B44-ABA7-5BA1651ECB7A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6834" y="5101027"/>
            <a:ext cx="1440000" cy="14400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B7C0CF4B-B2E6-4795-ACA8-C499C8B89A81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6834" y="826747"/>
            <a:ext cx="1440000" cy="14400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C7A6CF0E-88EA-43DF-A5F8-5A0D380E619D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5324" y="5123887"/>
            <a:ext cx="1440000" cy="1440000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B2BF008C-D070-46CD-9A9D-346E15BE446A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566" y="3683887"/>
            <a:ext cx="1440000" cy="144000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141A12C8-1842-45C4-998C-103B66A54AAF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2298" y="5123887"/>
            <a:ext cx="1440000" cy="144000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B29B22AE-DF7B-4D24-90FB-A81336E11882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2298" y="3683887"/>
            <a:ext cx="1440000" cy="1440000"/>
          </a:xfrm>
          <a:prstGeom prst="rect">
            <a:avLst/>
          </a:prstGeom>
        </p:spPr>
      </p:pic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67B876DB-16CE-47BD-A986-6161C2FE0645}"/>
              </a:ext>
            </a:extLst>
          </p:cNvPr>
          <p:cNvCxnSpPr>
            <a:cxnSpLocks/>
          </p:cNvCxnSpPr>
          <p:nvPr/>
        </p:nvCxnSpPr>
        <p:spPr>
          <a:xfrm>
            <a:off x="2072298" y="670560"/>
            <a:ext cx="59058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29C32B51-6C67-4768-B7A6-349E24B165E5}"/>
              </a:ext>
            </a:extLst>
          </p:cNvPr>
          <p:cNvSpPr txBox="1"/>
          <p:nvPr/>
        </p:nvSpPr>
        <p:spPr>
          <a:xfrm>
            <a:off x="2072298" y="135938"/>
            <a:ext cx="144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SARS-CoV-2</a:t>
            </a:r>
          </a:p>
          <a:p>
            <a:pPr algn="ctr"/>
            <a:r>
              <a:rPr lang="de-DE" sz="1200" dirty="0"/>
              <a:t>1E+04 cp/ml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5182A4D-0561-4279-BBC3-0614C6C30ADA}"/>
              </a:ext>
            </a:extLst>
          </p:cNvPr>
          <p:cNvSpPr txBox="1"/>
          <p:nvPr/>
        </p:nvSpPr>
        <p:spPr>
          <a:xfrm>
            <a:off x="5126834" y="135936"/>
            <a:ext cx="144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Influenza-A</a:t>
            </a:r>
          </a:p>
          <a:p>
            <a:pPr algn="ctr"/>
            <a:r>
              <a:rPr lang="de-DE" sz="1200" dirty="0"/>
              <a:t>Ca. 2E+02 cp/ml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3E1F36B-3BC5-4E8D-8A4C-1BEFE403FE9E}"/>
              </a:ext>
            </a:extLst>
          </p:cNvPr>
          <p:cNvSpPr txBox="1"/>
          <p:nvPr/>
        </p:nvSpPr>
        <p:spPr>
          <a:xfrm>
            <a:off x="3558018" y="135938"/>
            <a:ext cx="144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SARS-CoV-2</a:t>
            </a:r>
          </a:p>
          <a:p>
            <a:pPr algn="ctr"/>
            <a:r>
              <a:rPr lang="de-DE" sz="1200" dirty="0"/>
              <a:t>1E+03 cp/ml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A8ACC1B-6200-4715-8BBB-7CD4CEBF9608}"/>
              </a:ext>
            </a:extLst>
          </p:cNvPr>
          <p:cNvSpPr txBox="1"/>
          <p:nvPr/>
        </p:nvSpPr>
        <p:spPr>
          <a:xfrm>
            <a:off x="6566834" y="130802"/>
            <a:ext cx="144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Influenza-B</a:t>
            </a:r>
          </a:p>
          <a:p>
            <a:pPr algn="ctr"/>
            <a:r>
              <a:rPr lang="de-DE" sz="1200" dirty="0"/>
              <a:t>Ca. 2E+05 cp/ml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B04818C-E8CF-4B04-89BB-76BFD8B47124}"/>
              </a:ext>
            </a:extLst>
          </p:cNvPr>
          <p:cNvSpPr txBox="1"/>
          <p:nvPr/>
        </p:nvSpPr>
        <p:spPr>
          <a:xfrm>
            <a:off x="984904" y="1413450"/>
            <a:ext cx="9170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Channel 1</a:t>
            </a:r>
          </a:p>
          <a:p>
            <a:pPr algn="ctr"/>
            <a:r>
              <a:rPr lang="de-DE" sz="1200" dirty="0"/>
              <a:t>RdRp/Hel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0D4AEEC-3238-4D67-A340-16026C9ABE2F}"/>
              </a:ext>
            </a:extLst>
          </p:cNvPr>
          <p:cNvSpPr txBox="1"/>
          <p:nvPr/>
        </p:nvSpPr>
        <p:spPr>
          <a:xfrm>
            <a:off x="984904" y="2848247"/>
            <a:ext cx="9170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Channel 2</a:t>
            </a:r>
          </a:p>
          <a:p>
            <a:pPr algn="ctr"/>
            <a:r>
              <a:rPr lang="de-DE" sz="1200" dirty="0"/>
              <a:t>Sarbeco-E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7C6E7AA-266A-4EEF-9959-0DCD2AAB381D}"/>
              </a:ext>
            </a:extLst>
          </p:cNvPr>
          <p:cNvSpPr txBox="1"/>
          <p:nvPr/>
        </p:nvSpPr>
        <p:spPr>
          <a:xfrm>
            <a:off x="984904" y="4265387"/>
            <a:ext cx="9170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Channel 3</a:t>
            </a:r>
          </a:p>
          <a:p>
            <a:pPr algn="ctr"/>
            <a:r>
              <a:rPr lang="de-DE" sz="1200" dirty="0"/>
              <a:t>Influenza-A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FA2E8D2A-EA26-42E9-9826-41AA0B4679E0}"/>
              </a:ext>
            </a:extLst>
          </p:cNvPr>
          <p:cNvSpPr txBox="1"/>
          <p:nvPr/>
        </p:nvSpPr>
        <p:spPr>
          <a:xfrm>
            <a:off x="984904" y="5682527"/>
            <a:ext cx="9170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Channel 4</a:t>
            </a:r>
          </a:p>
          <a:p>
            <a:pPr algn="ctr"/>
            <a:r>
              <a:rPr lang="de-DE" sz="1200" dirty="0"/>
              <a:t>Influenza-B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F091DEA-72C0-4E66-87D7-D02A69793CF4}"/>
              </a:ext>
            </a:extLst>
          </p:cNvPr>
          <p:cNvSpPr txBox="1"/>
          <p:nvPr/>
        </p:nvSpPr>
        <p:spPr>
          <a:xfrm>
            <a:off x="193321" y="228270"/>
            <a:ext cx="1583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Supplement Figure 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48A23C5-8856-4A8C-A6A0-25271875C5B5}"/>
              </a:ext>
            </a:extLst>
          </p:cNvPr>
          <p:cNvSpPr txBox="1"/>
          <p:nvPr/>
        </p:nvSpPr>
        <p:spPr>
          <a:xfrm>
            <a:off x="488271" y="6518167"/>
            <a:ext cx="7954391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Supplement </a:t>
            </a:r>
            <a:r>
              <a:rPr lang="en-US" sz="1600" i="1" dirty="0"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Figure</a:t>
            </a:r>
            <a:r>
              <a:rPr lang="en-US" sz="16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 2: Amplification curves of the SC2/</a:t>
            </a:r>
            <a:r>
              <a:rPr lang="en-US" sz="16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InflA</a:t>
            </a:r>
            <a:r>
              <a:rPr lang="en-US" sz="16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/</a:t>
            </a:r>
            <a:r>
              <a:rPr lang="en-US" sz="16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InflB</a:t>
            </a:r>
            <a:r>
              <a:rPr lang="en-US" sz="16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-UCT using a Atto425 probe for detection of </a:t>
            </a:r>
            <a:r>
              <a:rPr lang="en-US" sz="16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RdRp</a:t>
            </a:r>
            <a:r>
              <a:rPr lang="en-US" sz="16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/Hel on channel one</a:t>
            </a:r>
            <a:r>
              <a:rPr lang="en-US" sz="1600" i="1" dirty="0"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. In this fashion, both SARS-CoV-2 targets can be analyzed separately. This leads to increased cross-talk of the Yakima-Yellow probe into Channel 2 due to lower background </a:t>
            </a:r>
            <a:r>
              <a:rPr lang="en-US" sz="1600" i="1" dirty="0" err="1"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fluourescence</a:t>
            </a:r>
            <a:r>
              <a:rPr lang="en-US" sz="1600" i="1" dirty="0">
                <a:latin typeface="Calibri" panose="020F0502020204030204" pitchFamily="34" charset="0"/>
                <a:ea typeface="Calibri" panose="020F0502020204030204" pitchFamily="34" charset="0"/>
                <a:cs typeface="TimesNewRomanPS-BoldMT"/>
              </a:rPr>
              <a:t>.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1410341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4</Words>
  <Application>Microsoft Office PowerPoint</Application>
  <PresentationFormat>On-screen Show (4:3)</PresentationFormat>
  <Paragraphs>20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minik Nörz</dc:creator>
  <cp:lastModifiedBy>Dominik Nörz</cp:lastModifiedBy>
  <cp:revision>15</cp:revision>
  <dcterms:created xsi:type="dcterms:W3CDTF">2020-07-26T12:23:13Z</dcterms:created>
  <dcterms:modified xsi:type="dcterms:W3CDTF">2020-09-04T10:08:24Z</dcterms:modified>
</cp:coreProperties>
</file>